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576" y="-8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8F3CCF-158A-4870-31AF-77839E41DD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A3EF453-D074-A1D3-3100-F34E23127C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9BC5A99-F662-CB7C-7E5C-1EEC7FF5B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028EEA-639A-4B81-2349-C8E7EC5E0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9AC0777-D69B-923C-F635-FACA32163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650389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752ED42-2D6C-3FA3-69E2-7194F1F57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897CBF4-2C6F-EB82-AE28-EB97998D96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875BE22-A482-FFA3-F75B-DBB4753F1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0DAF7E4-DCBD-36F4-C6E0-0137BB4AB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7DC4D99-CE89-A035-CB49-EA5DC6141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08260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7492FC5-A7D8-A3AF-8C00-C9EB1EA44A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5BBB5AB-2FC4-72EE-627E-AE0E4A8DA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1B706E0-6BD2-8E33-47A6-193E5B876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87BDE16-1D20-D095-9DE1-C8E389A40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3A5253-8BD7-D72F-0047-36878323B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966751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564BDB-6940-F5D9-D196-F2348E747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2BA13B4-B796-1E49-113E-7398CD3A92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0AFCF5F-EC72-6945-56B9-2B752530C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92D63A-D1C6-4EDF-3242-5AE3B4FD9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224C2E-61DA-FB33-6101-9806CC17E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158098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30825B-821F-2E1F-D4AC-418D69DC4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43922F5-0238-EF7E-6EC0-B572DAEA0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37E2AF2-C877-A1FB-26C7-41E887B60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39C20F5-7857-CC0B-0DD9-310B41691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17AC04-C0FE-42BB-9BC7-3E69B4720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717522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022825-7BE3-2656-20DE-30A1349AEF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3FDFDA8-650E-AA31-A4ED-823D02C049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B2D7E03-23AE-8581-71D8-113424419E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A1EDA19-7395-B4BE-F5FB-FA52FEC71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40BF28D-EB59-9A71-3104-C9C862B49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26F4C38-24FD-0C6E-3746-174631FCD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183630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07A9B3-9EAD-3519-D16D-F6B3FDC177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0BF581F-333A-8AD9-60A1-8BF439FD66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A958B42-4308-9452-C51D-069990B9D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A8C2E45-271C-2C5A-152F-7857104269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617C99D-CB5B-2907-30A9-08B6FCE101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D0ED11C-337E-2904-ADB0-9090C6E4D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DCE6850-524D-CF85-7A25-85CEDAC60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10C85BE-CC35-C9C9-A18C-5789D696D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50916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14A1D0-8F72-04FB-4F31-C93D7681B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1BF119E-124C-6297-FF2F-8E174875D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2947D25-695E-AFA7-D3F1-DF85A8B76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5A50534-0A53-E970-CA08-0F8ABF41B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46672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9EE9DEE-284B-736E-0549-D8EDFA8B8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F2B3B43-C4DB-5557-AB73-B750CB11D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2BD72AA-3700-1A45-CC11-B537E7102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27793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8552DF-BFB9-55C0-8026-19A1CA600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2803901-279F-89BD-CF35-3FC3B94DDC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BE39F4E-929C-0165-9B7D-43E7D81FB1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50D52FA-C560-A705-29EF-5EE1B9E47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E399CFC-1A28-2BDA-4450-51A13A31A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EB55126-03CB-38FD-EE0C-03B85802F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75111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264BC8-C350-41A0-F832-FB4C56B49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A3CF1A4-2C2E-780C-976C-C09E084280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E0B8F4E-2FE0-48BA-79DD-B34220541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15BE84C-94BA-FCED-3A22-7D224D7F0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D87188E-2904-91B4-013A-1CC85EB01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9FB046F-B5B1-7F5A-4E05-B2E0568F4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454463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C805770-5665-9BEC-A9CC-6189586DC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07C4FBE-866C-CD80-32C9-6F96963EE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FF222A3-D0FE-5D56-375F-6B72058753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B89421-4EF7-4551-B912-4E135E34A495}" type="datetimeFigureOut">
              <a:rPr lang="es-AR" smtClean="0"/>
              <a:t>16/5/2025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C398B6C-83C5-FBEA-3DAD-791AD5D330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B7B6770-EB2C-CAF4-82FF-3B4281D65F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AF7481-1212-4696-AA87-6833EE45419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98768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 plato de color azul&#10;&#10;El contenido generado por IA puede ser incorrecto.">
            <a:extLst>
              <a:ext uri="{FF2B5EF4-FFF2-40B4-BE49-F238E27FC236}">
                <a16:creationId xmlns:a16="http://schemas.microsoft.com/office/drawing/2014/main" id="{610E7277-53B3-78D7-E234-1B5288981B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9374" y="1195753"/>
            <a:ext cx="3645876" cy="2734407"/>
          </a:xfrm>
          <a:prstGeom prst="rect">
            <a:avLst/>
          </a:prstGeom>
        </p:spPr>
      </p:pic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7D6279A1-7E88-BC88-C5B1-195096FCB0F4}"/>
              </a:ext>
            </a:extLst>
          </p:cNvPr>
          <p:cNvCxnSpPr>
            <a:cxnSpLocks/>
          </p:cNvCxnSpPr>
          <p:nvPr/>
        </p:nvCxnSpPr>
        <p:spPr>
          <a:xfrm flipH="1">
            <a:off x="5101004" y="1652954"/>
            <a:ext cx="1512277" cy="1494692"/>
          </a:xfrm>
          <a:prstGeom prst="line">
            <a:avLst/>
          </a:prstGeom>
          <a:ln w="41275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17DE2C7D-A406-9EA2-DF2B-EE5106FEF211}"/>
              </a:ext>
            </a:extLst>
          </p:cNvPr>
          <p:cNvCxnSpPr>
            <a:cxnSpLocks/>
          </p:cNvCxnSpPr>
          <p:nvPr/>
        </p:nvCxnSpPr>
        <p:spPr>
          <a:xfrm flipH="1">
            <a:off x="5445919" y="2683669"/>
            <a:ext cx="126206" cy="116681"/>
          </a:xfrm>
          <a:prstGeom prst="line">
            <a:avLst/>
          </a:prstGeom>
          <a:ln w="82550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9957CD5-ED94-9ECB-80BE-E81EA0B5E8FD}"/>
              </a:ext>
            </a:extLst>
          </p:cNvPr>
          <p:cNvSpPr txBox="1"/>
          <p:nvPr/>
        </p:nvSpPr>
        <p:spPr>
          <a:xfrm>
            <a:off x="1733550" y="3971862"/>
            <a:ext cx="90296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dirty="0">
                <a:solidFill>
                  <a:srgbClr val="404040"/>
                </a:solidFill>
                <a:effectLst/>
                <a:latin typeface="DeepSeek-CJK-patch"/>
              </a:rPr>
              <a:t>Supplementary Figure S1. Measurement methodology for antifungal radial inhibition assays</a:t>
            </a:r>
            <a:br>
              <a:rPr lang="en-US" sz="1200" dirty="0"/>
            </a:br>
            <a:r>
              <a:rPr lang="en-US" sz="1200" b="0" i="0" dirty="0">
                <a:solidFill>
                  <a:srgbClr val="404040"/>
                </a:solidFill>
                <a:effectLst/>
                <a:latin typeface="DeepSeek-CJK-patch"/>
              </a:rPr>
              <a:t>Representative plate showing inhibition zone measurement between </a:t>
            </a:r>
            <a:r>
              <a:rPr lang="en-US" sz="1200" b="0" i="1" dirty="0">
                <a:solidFill>
                  <a:srgbClr val="404040"/>
                </a:solidFill>
                <a:effectLst/>
                <a:latin typeface="DeepSeek-CJK-patch"/>
              </a:rPr>
              <a:t>Fusarium </a:t>
            </a:r>
            <a:r>
              <a:rPr lang="en-US" sz="1200" b="0" i="1" dirty="0" err="1">
                <a:solidFill>
                  <a:srgbClr val="404040"/>
                </a:solidFill>
                <a:effectLst/>
                <a:latin typeface="DeepSeek-CJK-patch"/>
              </a:rPr>
              <a:t>graminearum</a:t>
            </a:r>
            <a:r>
              <a:rPr lang="en-US" sz="1200" b="0" i="0" dirty="0">
                <a:solidFill>
                  <a:srgbClr val="404040"/>
                </a:solidFill>
                <a:effectLst/>
                <a:latin typeface="DeepSeek-CJK-patch"/>
              </a:rPr>
              <a:t> (central plug) and bacterial isolates (peripheral colonies). The inhibition radius (red line) was measured using manual calipers along the colinear axis (black dotted line) connecting colony centers after 72 h at 22°C or until fungal growth reached the edge of the 120-mm-diameter plate.</a:t>
            </a:r>
            <a:endParaRPr lang="es-AR" sz="1200" dirty="0"/>
          </a:p>
        </p:txBody>
      </p:sp>
    </p:spTree>
    <p:extLst>
      <p:ext uri="{BB962C8B-B14F-4D97-AF65-F5344CB8AC3E}">
        <p14:creationId xmlns:p14="http://schemas.microsoft.com/office/powerpoint/2010/main" val="19614981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75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DeepSeek-CJK-patch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ín Espariz</dc:creator>
  <cp:lastModifiedBy>Martín Espariz</cp:lastModifiedBy>
  <cp:revision>2</cp:revision>
  <dcterms:created xsi:type="dcterms:W3CDTF">2025-05-16T15:07:41Z</dcterms:created>
  <dcterms:modified xsi:type="dcterms:W3CDTF">2025-05-16T16:16:29Z</dcterms:modified>
</cp:coreProperties>
</file>